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4" r:id="rId3"/>
    <p:sldId id="258" r:id="rId4"/>
    <p:sldId id="265" r:id="rId5"/>
    <p:sldId id="259" r:id="rId6"/>
    <p:sldId id="267" r:id="rId7"/>
    <p:sldId id="266" r:id="rId8"/>
    <p:sldId id="263" r:id="rId9"/>
    <p:sldId id="260" r:id="rId10"/>
    <p:sldId id="261" r:id="rId11"/>
    <p:sldId id="268" r:id="rId12"/>
    <p:sldId id="269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6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21D735-4E94-1A92-3FD6-05D815338B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107344-DB37-6AFB-F173-486D51396F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B6DCF4-F7C6-E74E-8383-50494D295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72952E-ABE1-E930-FA54-69FACF28C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27C50B-19A4-48E8-8269-8B6D4C69D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0050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A9CB4F-F56F-56A8-6A9F-C4712DA118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807F9D-E40A-98A9-7EF9-8AAE85E597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6A2D7F-011D-F381-270A-3AFD5E810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936207-2013-1840-56EE-FF02740C0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CD7892-6513-A616-8C58-2D3DBD6F2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5287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A751C5-41E9-3E98-237E-9867EF57B0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E1B6DF-71EA-09DB-7DCD-ED32836B8B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603FAF-FCD6-CB84-E661-BEF7D47C4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9172D8-02BA-BC9B-DFD2-06EF6FFD2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CE9A90-1AFF-B85C-A2EF-2F2F7FDA9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5631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33DC04-8C5F-9174-849E-7E837D19D8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D9751-6457-A2C0-8CBE-4E8F628422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9121DA-5D74-A18D-E190-887F65CB8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6F3545-9D79-EBC9-D5DA-277B1760F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32C55-B5BB-E202-7182-73F8D1057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869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9EB90B-F8FE-9C08-0692-DDBA0AC968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3DCA93-46C1-7B0D-9776-4A1E68F8CD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DE54D8-7063-5CBF-66F3-24FB3B452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0617B4-7216-142B-DC1C-05F41443A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FE2B34-0CC3-C46A-9F7D-13E1645DE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544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B4BADA-0477-6D52-D598-0DBBD5D79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769BFB-4195-A17A-C484-68A0F311B0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A0D14A-5888-8883-CC60-547AD73135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0E88C8-9A9A-648C-9C6D-080190C69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BD78CF-6793-7020-5182-B2F31A491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66A90E-5767-6418-1F77-91F7E169A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96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AC1C8A-E16E-054A-8D39-EE36D2F15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EE3779-F9C4-E63E-6AAA-103827ED80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5B97B2-D732-0642-C897-1873FFE07B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E20C36-5B54-20B4-6420-6244175235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3E82D3-65D9-BB32-BC62-FCF9C613B5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34DB52A-5C97-B770-88A0-5D05190DCE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97735D5-225C-8917-89FB-873C5352A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E866D61-E223-90D3-7B9C-20909C16D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5526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B3504-661F-B726-B355-A26999918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5FE9497-33E4-4250-C04C-ACD2CA2A0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1F757E-E429-5734-34CD-7FF8C442E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F147DB-37E6-024F-F25B-AD18CCCE5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0173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7F5A93-DA7B-D714-F24C-A0863FEFE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755EC1-B953-A804-5B2D-989115F60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13056A-55F3-284D-D35D-73DF9C54E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3107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5EA5D9-227C-94FD-5337-7A7E30D2E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4EAA23-C218-8C4F-5E32-6837C02764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A9050F-4CC9-86FD-3D5B-8E45887E2D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2D5E20-8BE2-9548-8E89-A6F03D31E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3021F1-9567-907F-CC6D-8E5151717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8262A7-CCEE-52D4-0C21-FD6986FB3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44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8A11EF-966C-44BF-2504-01C42EE7BB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454B899-5928-0708-F93B-D918770628B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630C62-014D-3620-DD96-EB5F0D6982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BF03B5-3A56-4F82-811A-400E8E7AF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CB910D-703B-E456-E499-7AEBC91C7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4DA467-8E99-EB38-800C-E13ED0E1B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5175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62B723-083B-9448-4C0B-7CEF4AB503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2C90A3-3687-642F-1F8C-2F71B21783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769C9B-00CD-3A93-B2A4-ECDD523FAF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95BBF8-A624-4C89-B115-9AB63E985288}" type="datetimeFigureOut">
              <a:rPr lang="en-GB" smtClean="0"/>
              <a:t>31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637C31-32CC-A788-17FD-7D22534DCE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164364-0889-0B3E-FBCD-78FA3225BC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FA4739-E537-4407-B39A-798045DC5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00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F9993F6-5BD6-A10F-19E7-70A224144389}"/>
              </a:ext>
            </a:extLst>
          </p:cNvPr>
          <p:cNvSpPr txBox="1"/>
          <p:nvPr/>
        </p:nvSpPr>
        <p:spPr>
          <a:xfrm>
            <a:off x="4857307" y="572571"/>
            <a:ext cx="1099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4A</a:t>
            </a:r>
          </a:p>
        </p:txBody>
      </p:sp>
      <p:pic>
        <p:nvPicPr>
          <p:cNvPr id="12" name="Content Placeholder 11" descr="A diagram of a structure&#10;&#10;AI-generated content may be incorrect.">
            <a:extLst>
              <a:ext uri="{FF2B5EF4-FFF2-40B4-BE49-F238E27FC236}">
                <a16:creationId xmlns:a16="http://schemas.microsoft.com/office/drawing/2014/main" id="{2E46FFD0-DE63-DBFA-D7E6-1EEBC009734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336" y="1711843"/>
            <a:ext cx="11410198" cy="4246002"/>
          </a:xfrm>
        </p:spPr>
      </p:pic>
    </p:spTree>
    <p:extLst>
      <p:ext uri="{BB962C8B-B14F-4D97-AF65-F5344CB8AC3E}">
        <p14:creationId xmlns:p14="http://schemas.microsoft.com/office/powerpoint/2010/main" val="26250389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2918F75-F586-E976-529A-3FB7171DBB5D}"/>
              </a:ext>
            </a:extLst>
          </p:cNvPr>
          <p:cNvSpPr txBox="1"/>
          <p:nvPr/>
        </p:nvSpPr>
        <p:spPr>
          <a:xfrm>
            <a:off x="429273" y="3317358"/>
            <a:ext cx="8178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99R1</a:t>
            </a:r>
          </a:p>
          <a:p>
            <a:r>
              <a:rPr lang="en-GB" dirty="0"/>
              <a:t>CDA</a:t>
            </a:r>
          </a:p>
        </p:txBody>
      </p:sp>
      <p:pic>
        <p:nvPicPr>
          <p:cNvPr id="8" name="Picture 7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3EAA9B0E-5852-99FA-ACCC-690F402170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3563" y="0"/>
            <a:ext cx="4479616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89AD29D-CE6A-65A2-424F-BAF6B378017D}"/>
              </a:ext>
            </a:extLst>
          </p:cNvPr>
          <p:cNvSpPr txBox="1"/>
          <p:nvPr/>
        </p:nvSpPr>
        <p:spPr>
          <a:xfrm>
            <a:off x="350909" y="2313101"/>
            <a:ext cx="24334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</a:t>
            </a:r>
          </a:p>
          <a:p>
            <a:r>
              <a:rPr lang="en-GB" dirty="0"/>
              <a:t>Figure EV10 (E) and (F) </a:t>
            </a:r>
          </a:p>
        </p:txBody>
      </p:sp>
      <p:pic>
        <p:nvPicPr>
          <p:cNvPr id="5" name="Picture 4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D7B1EBE7-E5DA-B943-B4F8-EB1DDCDCB9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2629" y="0"/>
            <a:ext cx="512093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384273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0C446AC6-E86A-7E45-7785-A7715431247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1317" y="365125"/>
            <a:ext cx="3533558" cy="5992093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47AAF07-4367-C51A-647E-FF0C899541EB}"/>
              </a:ext>
            </a:extLst>
          </p:cNvPr>
          <p:cNvSpPr txBox="1"/>
          <p:nvPr/>
        </p:nvSpPr>
        <p:spPr>
          <a:xfrm>
            <a:off x="680484" y="2881423"/>
            <a:ext cx="5081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orrected T211 </a:t>
            </a:r>
            <a:r>
              <a:rPr lang="en-GB" dirty="0" err="1"/>
              <a:t>DeerAnalysis</a:t>
            </a:r>
            <a:r>
              <a:rPr lang="en-GB" dirty="0"/>
              <a:t> figure for Figure EV8</a:t>
            </a:r>
          </a:p>
        </p:txBody>
      </p:sp>
    </p:spTree>
    <p:extLst>
      <p:ext uri="{BB962C8B-B14F-4D97-AF65-F5344CB8AC3E}">
        <p14:creationId xmlns:p14="http://schemas.microsoft.com/office/powerpoint/2010/main" val="33524219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94F3DC-4319-9814-3E94-88BF618A2C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Content Placeholder 4" descr="A graph of a normalized echo intensity&#10;&#10;AI-generated content may be incorrect.">
            <a:extLst>
              <a:ext uri="{FF2B5EF4-FFF2-40B4-BE49-F238E27FC236}">
                <a16:creationId xmlns:a16="http://schemas.microsoft.com/office/drawing/2014/main" id="{34E9EE48-BC4F-2DC1-B9E3-69E6B7E717D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14" y="0"/>
            <a:ext cx="4691743" cy="6832900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530CC6B-9C13-AEE8-AD23-FF28C4FED52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203063" y="0"/>
            <a:ext cx="428136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49222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9FB7A6C-DA00-CF2C-67FA-3E11A658EF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738602" y="0"/>
            <a:ext cx="4245883" cy="6858000"/>
          </a:xfrm>
          <a:prstGeom prst="rect">
            <a:avLst/>
          </a:prstGeom>
        </p:spPr>
      </p:pic>
      <p:pic>
        <p:nvPicPr>
          <p:cNvPr id="11" name="Content Placeholder 10">
            <a:extLst>
              <a:ext uri="{FF2B5EF4-FFF2-40B4-BE49-F238E27FC236}">
                <a16:creationId xmlns:a16="http://schemas.microsoft.com/office/drawing/2014/main" id="{40D58163-632B-7C0E-B279-619496E7A74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7735" y="0"/>
            <a:ext cx="4245884" cy="6870748"/>
          </a:xfr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5DED5AD4-B603-CDA2-B6DC-ED06B1A0EDD1}"/>
              </a:ext>
            </a:extLst>
          </p:cNvPr>
          <p:cNvSpPr txBox="1"/>
          <p:nvPr/>
        </p:nvSpPr>
        <p:spPr>
          <a:xfrm>
            <a:off x="9159469" y="3059668"/>
            <a:ext cx="3429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25R1 </a:t>
            </a:r>
            <a:r>
              <a:rPr lang="en-GB" dirty="0" err="1"/>
              <a:t>DeerAnalysis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492AE0A-F10E-2390-820B-418FEC90CB66}"/>
              </a:ext>
            </a:extLst>
          </p:cNvPr>
          <p:cNvSpPr txBox="1"/>
          <p:nvPr/>
        </p:nvSpPr>
        <p:spPr>
          <a:xfrm>
            <a:off x="9239337" y="2272879"/>
            <a:ext cx="185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4B and 4C</a:t>
            </a:r>
          </a:p>
        </p:txBody>
      </p:sp>
    </p:spTree>
    <p:extLst>
      <p:ext uri="{BB962C8B-B14F-4D97-AF65-F5344CB8AC3E}">
        <p14:creationId xmlns:p14="http://schemas.microsoft.com/office/powerpoint/2010/main" val="21385920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B7141941-8538-DAF1-C5A9-13BFF874F0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905422" y="15920"/>
            <a:ext cx="4660336" cy="685799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1891208-FB8A-B649-B362-435E269B65E6}"/>
              </a:ext>
            </a:extLst>
          </p:cNvPr>
          <p:cNvSpPr txBox="1"/>
          <p:nvPr/>
        </p:nvSpPr>
        <p:spPr>
          <a:xfrm>
            <a:off x="1001232" y="2709007"/>
            <a:ext cx="3429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25R1 </a:t>
            </a:r>
            <a:r>
              <a:rPr lang="en-GB" dirty="0" err="1"/>
              <a:t>DeerAnalysis</a:t>
            </a:r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5226444-43C9-7147-7634-708AEBCD295A}"/>
              </a:ext>
            </a:extLst>
          </p:cNvPr>
          <p:cNvSpPr txBox="1"/>
          <p:nvPr/>
        </p:nvSpPr>
        <p:spPr>
          <a:xfrm>
            <a:off x="1593502" y="3221298"/>
            <a:ext cx="1122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4D</a:t>
            </a:r>
          </a:p>
        </p:txBody>
      </p:sp>
    </p:spTree>
    <p:extLst>
      <p:ext uri="{BB962C8B-B14F-4D97-AF65-F5344CB8AC3E}">
        <p14:creationId xmlns:p14="http://schemas.microsoft.com/office/powerpoint/2010/main" val="35961924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79C8CB1D-915E-47C6-FD7E-CC2FB191586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992795" y="-1"/>
            <a:ext cx="3961437" cy="6704213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470006A-35DF-29C9-B798-87E96D843EA9}"/>
              </a:ext>
            </a:extLst>
          </p:cNvPr>
          <p:cNvSpPr txBox="1"/>
          <p:nvPr/>
        </p:nvSpPr>
        <p:spPr>
          <a:xfrm>
            <a:off x="276446" y="3429000"/>
            <a:ext cx="149137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99R1</a:t>
            </a:r>
          </a:p>
          <a:p>
            <a:r>
              <a:rPr lang="en-GB" dirty="0" err="1"/>
              <a:t>DeerAnalysis</a:t>
            </a:r>
            <a:endParaRPr lang="en-GB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25AC9BC-6E42-4878-48C7-5714C4D016B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4398" y="-1"/>
            <a:ext cx="3859236" cy="6858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98595E0-2206-FF6D-AC15-3B4DAA5C9355}"/>
              </a:ext>
            </a:extLst>
          </p:cNvPr>
          <p:cNvSpPr txBox="1"/>
          <p:nvPr/>
        </p:nvSpPr>
        <p:spPr>
          <a:xfrm>
            <a:off x="117171" y="4356859"/>
            <a:ext cx="180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4E and 4F</a:t>
            </a:r>
          </a:p>
        </p:txBody>
      </p:sp>
    </p:spTree>
    <p:extLst>
      <p:ext uri="{BB962C8B-B14F-4D97-AF65-F5344CB8AC3E}">
        <p14:creationId xmlns:p14="http://schemas.microsoft.com/office/powerpoint/2010/main" val="7823000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173ADA14-60E2-9912-5D5F-6AF1BDDB0B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935896" y="0"/>
            <a:ext cx="4459749" cy="6858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ECF1272-9431-461B-45E7-8DA0E708D49F}"/>
              </a:ext>
            </a:extLst>
          </p:cNvPr>
          <p:cNvSpPr txBox="1"/>
          <p:nvPr/>
        </p:nvSpPr>
        <p:spPr>
          <a:xfrm>
            <a:off x="276446" y="3429000"/>
            <a:ext cx="149137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99R1</a:t>
            </a:r>
          </a:p>
          <a:p>
            <a:r>
              <a:rPr lang="en-GB" dirty="0" err="1"/>
              <a:t>DeerAnalysis</a:t>
            </a:r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A925D52-F457-856D-DA68-CCCFF341A553}"/>
              </a:ext>
            </a:extLst>
          </p:cNvPr>
          <p:cNvSpPr txBox="1"/>
          <p:nvPr/>
        </p:nvSpPr>
        <p:spPr>
          <a:xfrm>
            <a:off x="2500070" y="3567499"/>
            <a:ext cx="11270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4G</a:t>
            </a:r>
          </a:p>
        </p:txBody>
      </p:sp>
    </p:spTree>
    <p:extLst>
      <p:ext uri="{BB962C8B-B14F-4D97-AF65-F5344CB8AC3E}">
        <p14:creationId xmlns:p14="http://schemas.microsoft.com/office/powerpoint/2010/main" val="21957033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5D66EEE-827E-4AA9-00E7-8ADCCD93190B}"/>
              </a:ext>
            </a:extLst>
          </p:cNvPr>
          <p:cNvSpPr txBox="1"/>
          <p:nvPr/>
        </p:nvSpPr>
        <p:spPr>
          <a:xfrm>
            <a:off x="1431638" y="1770840"/>
            <a:ext cx="3202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EV.9 (A)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CFC231F-C574-FECD-1BDC-9D5BC480EA70}"/>
              </a:ext>
            </a:extLst>
          </p:cNvPr>
          <p:cNvSpPr txBox="1"/>
          <p:nvPr/>
        </p:nvSpPr>
        <p:spPr>
          <a:xfrm>
            <a:off x="1860698" y="2434856"/>
            <a:ext cx="1664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211R1 </a:t>
            </a:r>
            <a:r>
              <a:rPr lang="en-GB" dirty="0" err="1"/>
              <a:t>cwEPR</a:t>
            </a:r>
            <a:endParaRPr lang="en-GB" dirty="0"/>
          </a:p>
        </p:txBody>
      </p:sp>
      <p:pic>
        <p:nvPicPr>
          <p:cNvPr id="5" name="Picture 4" descr="A graph of a heart beat&#10;&#10;AI-generated content may be incorrect.">
            <a:extLst>
              <a:ext uri="{FF2B5EF4-FFF2-40B4-BE49-F238E27FC236}">
                <a16:creationId xmlns:a16="http://schemas.microsoft.com/office/drawing/2014/main" id="{D4AF0108-F6D4-3D42-0171-35040B956F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318"/>
          <a:stretch/>
        </p:blipFill>
        <p:spPr>
          <a:xfrm>
            <a:off x="5330823" y="1212111"/>
            <a:ext cx="3805721" cy="33386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97585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717361B-8602-FD43-177F-689007EBEF28}"/>
              </a:ext>
            </a:extLst>
          </p:cNvPr>
          <p:cNvSpPr txBox="1"/>
          <p:nvPr/>
        </p:nvSpPr>
        <p:spPr>
          <a:xfrm>
            <a:off x="1431638" y="1770840"/>
            <a:ext cx="31653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EV9 (B)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AF4C418-9C81-283B-7F7A-AB202E2A2F29}"/>
              </a:ext>
            </a:extLst>
          </p:cNvPr>
          <p:cNvSpPr txBox="1"/>
          <p:nvPr/>
        </p:nvSpPr>
        <p:spPr>
          <a:xfrm>
            <a:off x="1860698" y="2434856"/>
            <a:ext cx="1553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525R1 </a:t>
            </a:r>
            <a:r>
              <a:rPr lang="en-GB" dirty="0" err="1"/>
              <a:t>cwEPR</a:t>
            </a:r>
            <a:endParaRPr lang="en-GB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648E13C-8498-208E-0CFB-5F41C324A4D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47096"/>
          <a:stretch/>
        </p:blipFill>
        <p:spPr>
          <a:xfrm>
            <a:off x="5617231" y="1690688"/>
            <a:ext cx="3743268" cy="33897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42616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F45BBF3-6B0C-AE4C-A933-2A6C6E98601E}"/>
              </a:ext>
            </a:extLst>
          </p:cNvPr>
          <p:cNvSpPr txBox="1"/>
          <p:nvPr/>
        </p:nvSpPr>
        <p:spPr>
          <a:xfrm>
            <a:off x="1860698" y="2434856"/>
            <a:ext cx="1553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99R1 </a:t>
            </a:r>
            <a:r>
              <a:rPr lang="en-GB" dirty="0" err="1"/>
              <a:t>cwEPR</a:t>
            </a:r>
            <a:endParaRPr lang="en-GB" dirty="0"/>
          </a:p>
        </p:txBody>
      </p:sp>
      <p:pic>
        <p:nvPicPr>
          <p:cNvPr id="7" name="Content Placeholder 6" descr="A graph of a heart rate&#10;&#10;AI-generated content may be incorrect.">
            <a:extLst>
              <a:ext uri="{FF2B5EF4-FFF2-40B4-BE49-F238E27FC236}">
                <a16:creationId xmlns:a16="http://schemas.microsoft.com/office/drawing/2014/main" id="{776EF06B-01C3-1706-921E-BA23CD8EEFD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92"/>
          <a:stretch/>
        </p:blipFill>
        <p:spPr>
          <a:xfrm>
            <a:off x="4767943" y="197160"/>
            <a:ext cx="3744685" cy="6587814"/>
          </a:xfr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03731F0-239D-D760-0301-21C2058D59A1}"/>
              </a:ext>
            </a:extLst>
          </p:cNvPr>
          <p:cNvSpPr txBox="1"/>
          <p:nvPr/>
        </p:nvSpPr>
        <p:spPr>
          <a:xfrm>
            <a:off x="1431638" y="1770840"/>
            <a:ext cx="3139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EV9(C) </a:t>
            </a:r>
          </a:p>
        </p:txBody>
      </p:sp>
    </p:spTree>
    <p:extLst>
      <p:ext uri="{BB962C8B-B14F-4D97-AF65-F5344CB8AC3E}">
        <p14:creationId xmlns:p14="http://schemas.microsoft.com/office/powerpoint/2010/main" val="8125089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CC344174-FFC8-4F9A-3732-989DB42B56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2795" y="0"/>
            <a:ext cx="4464142" cy="6858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2113B2F-84F2-EF04-07B1-7E5BB02AEAFD}"/>
              </a:ext>
            </a:extLst>
          </p:cNvPr>
          <p:cNvSpPr txBox="1"/>
          <p:nvPr/>
        </p:nvSpPr>
        <p:spPr>
          <a:xfrm>
            <a:off x="738931" y="3304847"/>
            <a:ext cx="8178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25R1</a:t>
            </a:r>
          </a:p>
          <a:p>
            <a:r>
              <a:rPr lang="en-GB" dirty="0"/>
              <a:t>CD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6D68A53-5945-56E7-6EE7-714AD06A36E9}"/>
              </a:ext>
            </a:extLst>
          </p:cNvPr>
          <p:cNvSpPr txBox="1"/>
          <p:nvPr/>
        </p:nvSpPr>
        <p:spPr>
          <a:xfrm>
            <a:off x="350909" y="2313101"/>
            <a:ext cx="25023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</a:t>
            </a:r>
          </a:p>
          <a:p>
            <a:r>
              <a:rPr lang="en-GB" dirty="0"/>
              <a:t>Figure EV10 (C) and (D) </a:t>
            </a:r>
          </a:p>
        </p:txBody>
      </p:sp>
      <p:pic>
        <p:nvPicPr>
          <p:cNvPr id="9" name="Content Placeholder 8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AB48ADDE-C039-6328-5230-10910BC28C1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6005" y="0"/>
            <a:ext cx="5006402" cy="6739836"/>
          </a:xfrm>
        </p:spPr>
      </p:pic>
    </p:spTree>
    <p:extLst>
      <p:ext uri="{BB962C8B-B14F-4D97-AF65-F5344CB8AC3E}">
        <p14:creationId xmlns:p14="http://schemas.microsoft.com/office/powerpoint/2010/main" val="101206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6</TotalTime>
  <Words>79</Words>
  <Application>Microsoft Office PowerPoint</Application>
  <PresentationFormat>Widescreen</PresentationFormat>
  <Paragraphs>26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inyu Liu</dc:creator>
  <cp:lastModifiedBy>Xinyu Liu</cp:lastModifiedBy>
  <cp:revision>21</cp:revision>
  <dcterms:created xsi:type="dcterms:W3CDTF">2025-03-23T16:12:02Z</dcterms:created>
  <dcterms:modified xsi:type="dcterms:W3CDTF">2025-03-31T10:58:37Z</dcterms:modified>
</cp:coreProperties>
</file>